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12192000" cy="6858000"/>
  <p:notesSz cx="6858000" cy="994727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-102" y="-6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9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9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0CB566-3B20-4154-A778-75285434B7EA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44500" y="1243013"/>
            <a:ext cx="5969000" cy="33575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787126"/>
            <a:ext cx="5486400" cy="391674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48185"/>
            <a:ext cx="2971800" cy="499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9448185"/>
            <a:ext cx="2971800" cy="499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726D09-22FA-4882-9C88-E540C433E56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65007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87851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11659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31900090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609600" y="274639"/>
            <a:ext cx="10972800" cy="585152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xmlns="" id="{D07C8E89-CA08-4FDD-8243-ECECF9EF71B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xmlns="" id="{99433B9F-20B7-40EF-9D0F-B082E5CF0F91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xmlns="" id="{3600D71F-D712-4988-8D6B-C3A8465A30C4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E1A33DB-13CC-4D99-8BCC-34AE9FC60BA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xmlns="" val="2179209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00248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87311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399282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63541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689847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994318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22527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91661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454135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431261077"/>
              </p:ext>
            </p:extLst>
          </p:nvPr>
        </p:nvGraphicFramePr>
        <p:xfrm>
          <a:off x="487014" y="1729411"/>
          <a:ext cx="11201403" cy="4452725"/>
        </p:xfrm>
        <a:graphic>
          <a:graphicData uri="http://schemas.openxmlformats.org/drawingml/2006/table">
            <a:tbl>
              <a:tblPr/>
              <a:tblGrid>
                <a:gridCol w="1499357">
                  <a:extLst>
                    <a:ext uri="{9D8B030D-6E8A-4147-A177-3AD203B41FA5}">
                      <a16:colId xmlns:a16="http://schemas.microsoft.com/office/drawing/2014/main" xmlns="" val="1123358056"/>
                    </a:ext>
                  </a:extLst>
                </a:gridCol>
                <a:gridCol w="814868">
                  <a:extLst>
                    <a:ext uri="{9D8B030D-6E8A-4147-A177-3AD203B41FA5}">
                      <a16:colId xmlns:a16="http://schemas.microsoft.com/office/drawing/2014/main" xmlns="" val="2403365154"/>
                    </a:ext>
                  </a:extLst>
                </a:gridCol>
                <a:gridCol w="912652">
                  <a:extLst>
                    <a:ext uri="{9D8B030D-6E8A-4147-A177-3AD203B41FA5}">
                      <a16:colId xmlns:a16="http://schemas.microsoft.com/office/drawing/2014/main" xmlns="" val="1289817034"/>
                    </a:ext>
                  </a:extLst>
                </a:gridCol>
                <a:gridCol w="814868">
                  <a:extLst>
                    <a:ext uri="{9D8B030D-6E8A-4147-A177-3AD203B41FA5}">
                      <a16:colId xmlns:a16="http://schemas.microsoft.com/office/drawing/2014/main" xmlns="" val="1342806118"/>
                    </a:ext>
                  </a:extLst>
                </a:gridCol>
                <a:gridCol w="814868">
                  <a:extLst>
                    <a:ext uri="{9D8B030D-6E8A-4147-A177-3AD203B41FA5}">
                      <a16:colId xmlns:a16="http://schemas.microsoft.com/office/drawing/2014/main" xmlns="" val="1751262923"/>
                    </a:ext>
                  </a:extLst>
                </a:gridCol>
                <a:gridCol w="550277">
                  <a:extLst>
                    <a:ext uri="{9D8B030D-6E8A-4147-A177-3AD203B41FA5}">
                      <a16:colId xmlns:a16="http://schemas.microsoft.com/office/drawing/2014/main" xmlns="" val="1289186558"/>
                    </a:ext>
                  </a:extLst>
                </a:gridCol>
                <a:gridCol w="5794513">
                  <a:extLst>
                    <a:ext uri="{9D8B030D-6E8A-4147-A177-3AD203B41FA5}">
                      <a16:colId xmlns:a16="http://schemas.microsoft.com/office/drawing/2014/main" xmlns="" val="440111861"/>
                    </a:ext>
                  </a:extLst>
                </a:gridCol>
              </a:tblGrid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ccession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c1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g2 ratio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valu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DR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escription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40209577"/>
                  </a:ext>
                </a:extLst>
              </a:tr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9g1266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074.2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3817.9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.7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739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lucose-1-phosphate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denylyltransferas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large subunit, chloroplast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recurso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88850178"/>
                  </a:ext>
                </a:extLst>
              </a:tr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6g46284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87.9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88.5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.1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129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lycosyl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hydrolase, family 31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15707929"/>
                  </a:ext>
                </a:extLst>
              </a:tr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6g4634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295.2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383.9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8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177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lycosyl hydrolase, family 31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05565113"/>
                  </a:ext>
                </a:extLst>
              </a:tr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3g5509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1260.5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0717.5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8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189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lpha-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lucan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hosphorylas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isozym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66620754"/>
                  </a:ext>
                </a:extLst>
              </a:tr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10g1114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690.6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495.4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7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166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hosphoglucomutas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1860147"/>
                  </a:ext>
                </a:extLst>
              </a:tr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5g5038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2611.3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1749.4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7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1218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lucose-1-phosphate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denylyltransferas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large subunit, chloroplast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recurso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13555987"/>
                  </a:ext>
                </a:extLst>
              </a:tr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1g6327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9197.3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5705.1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7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33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lpha-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lucan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hosphorylas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isozym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69927083"/>
                  </a:ext>
                </a:extLst>
              </a:tr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3g2212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60.0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28.9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6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13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ucrose synthas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44740210"/>
                  </a:ext>
                </a:extLst>
              </a:tr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1g7052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05.9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37.8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6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244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s1bglu5 - beta-glucosidase homologue, similar to G. max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isohydroxyurat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hydrola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25190617"/>
                  </a:ext>
                </a:extLst>
              </a:tr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1g5393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199.4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241.2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6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42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hexokinas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69826693"/>
                  </a:ext>
                </a:extLst>
              </a:tr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7g4339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587.1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7111.4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5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13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-alpha-glucanotransferase, chloroplast precursor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26115163"/>
                  </a:ext>
                </a:extLst>
              </a:tr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2g3266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919.8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389.7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5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154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,4-alpha-glucan-branching enzyme, chloroplast precursor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77244839"/>
                  </a:ext>
                </a:extLst>
              </a:tr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4g3374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768.5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052.4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6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514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lycosyl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hydrolases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91764870"/>
                  </a:ext>
                </a:extLst>
              </a:tr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7g4628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018.4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23.7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6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885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s7bglu26 - beta-mannosidase/glucosidase/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exoglucanas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16395539"/>
                  </a:ext>
                </a:extLst>
              </a:tr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3g4960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296.9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471.4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5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114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Os3bglu7 - beta-glucosidase, exo-beta-glucans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67649886"/>
                  </a:ext>
                </a:extLst>
              </a:tr>
              <a:tr h="2619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3g1214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199.6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45.4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5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318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lucan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endo-1,3-beta-glucosidase precursor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84025729"/>
                  </a:ext>
                </a:extLst>
              </a:tr>
            </a:tbl>
          </a:graphicData>
        </a:graphic>
      </p:graphicFrame>
      <p:sp>
        <p:nvSpPr>
          <p:cNvPr id="4" name="矩形 3"/>
          <p:cNvSpPr/>
          <p:nvPr/>
        </p:nvSpPr>
        <p:spPr>
          <a:xfrm>
            <a:off x="417440" y="999387"/>
            <a:ext cx="1024061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kern="0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zh-CN" b="1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.5-fold alterations of proteins involved in starch and sucrose metabolism in comparison of </a:t>
            </a:r>
            <a:r>
              <a:rPr lang="en-US" altLang="zh-CN" i="1" dirty="0">
                <a:latin typeface="Arial" panose="020B0604020202020204" pitchFamily="34" charset="0"/>
                <a:cs typeface="Arial" panose="020B0604020202020204" pitchFamily="34" charset="0"/>
              </a:rPr>
              <a:t>fc17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iTRAQ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data to that of the WT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766138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35</TotalTime>
  <Words>246</Words>
  <Application>Microsoft Office PowerPoint</Application>
  <PresentationFormat>Custom</PresentationFormat>
  <Paragraphs>1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0012761</cp:lastModifiedBy>
  <cp:revision>97</cp:revision>
  <cp:lastPrinted>2018-10-21T01:09:07Z</cp:lastPrinted>
  <dcterms:created xsi:type="dcterms:W3CDTF">2018-01-28T13:46:17Z</dcterms:created>
  <dcterms:modified xsi:type="dcterms:W3CDTF">2018-10-27T13:11:20Z</dcterms:modified>
</cp:coreProperties>
</file>